
<file path=[Content_Types].xml><?xml version="1.0" encoding="utf-8"?>
<Types xmlns="http://schemas.openxmlformats.org/package/2006/content-types">
  <Default Extension="fntdata" ContentType="application/x-fontdata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60" r:id="rId1"/>
  </p:sldMasterIdLst>
  <p:notesMasterIdLst>
    <p:notesMasterId r:id="rId3"/>
  </p:notesMasterIdLst>
  <p:sldIdLst>
    <p:sldId id="277" r:id="rId2"/>
  </p:sldIdLst>
  <p:sldSz cx="6858000" cy="9906000" type="A4"/>
  <p:notesSz cx="6858000" cy="9144000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  <p:embeddedFont>
      <p:font typeface="Calibri Light" panose="020F0302020204030204" pitchFamily="34" charset="0"/>
      <p:regular r:id="rId8"/>
      <p:italic r:id="rId9"/>
    </p:embeddedFont>
  </p:embeddedFont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320" userDrawn="1">
          <p15:clr>
            <a:srgbClr val="A4A3A4"/>
          </p15:clr>
        </p15:guide>
        <p15:guide id="2" pos="2069" userDrawn="1">
          <p15:clr>
            <a:srgbClr val="A4A3A4"/>
          </p15:clr>
        </p15:guide>
        <p15:guide id="3" pos="2341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notes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392300E-59B8-EE35-FC6A-43AB0AD735F4}" name="Ricardo Nilo Poyanco" initials="RNP" userId="3ada18ebad741824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homas Dussarrat" initials="TD" lastIdx="5" clrIdx="0">
    <p:extLst>
      <p:ext uri="{19B8F6BF-5375-455C-9EA6-DF929625EA0E}">
        <p15:presenceInfo xmlns:p15="http://schemas.microsoft.com/office/powerpoint/2012/main" userId="abdcf33d1325a05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918A"/>
    <a:srgbClr val="ADD9C8"/>
    <a:srgbClr val="BDD9D9"/>
    <a:srgbClr val="FFF0EE"/>
    <a:srgbClr val="FDE1DC"/>
    <a:srgbClr val="FAD1CC"/>
    <a:srgbClr val="FAC2BA"/>
    <a:srgbClr val="F0978A"/>
    <a:srgbClr val="EB877A"/>
    <a:srgbClr val="E6786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425" autoAdjust="0"/>
    <p:restoredTop sz="95647" autoAdjust="0"/>
  </p:normalViewPr>
  <p:slideViewPr>
    <p:cSldViewPr snapToGrid="0" showGuides="1">
      <p:cViewPr varScale="1">
        <p:scale>
          <a:sx n="43" d="100"/>
          <a:sy n="43" d="100"/>
        </p:scale>
        <p:origin x="2520" y="60"/>
      </p:cViewPr>
      <p:guideLst>
        <p:guide orient="horz" pos="5320"/>
        <p:guide pos="2069"/>
        <p:guide pos="2341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66" d="100"/>
        <a:sy n="66" d="100"/>
      </p:scale>
      <p:origin x="0" y="0"/>
    </p:cViewPr>
  </p:notesTextViewPr>
  <p:notesViewPr>
    <p:cSldViewPr snapToGrid="0" showGuides="1">
      <p:cViewPr varScale="1">
        <p:scale>
          <a:sx n="52" d="100"/>
          <a:sy n="52" d="100"/>
        </p:scale>
        <p:origin x="2862" y="84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presProps" Target="presProps.xml"/><Relationship Id="rId5" Type="http://schemas.openxmlformats.org/officeDocument/2006/relationships/font" Target="fonts/font2.fntdata"/><Relationship Id="rId15" Type="http://schemas.microsoft.com/office/2018/10/relationships/authors" Target="authors.xml"/><Relationship Id="rId10" Type="http://schemas.openxmlformats.org/officeDocument/2006/relationships/commentAuthors" Target="commentAuthors.xml"/><Relationship Id="rId4" Type="http://schemas.openxmlformats.org/officeDocument/2006/relationships/font" Target="fonts/font1.fntdata"/><Relationship Id="rId9" Type="http://schemas.openxmlformats.org/officeDocument/2006/relationships/font" Target="fonts/font6.fntdata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A9A0E6-6A3F-47B0-8DCE-2C95E7DF736B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 dirty="0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366D59-3C6A-44AB-90AA-10775F3CEE1B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3904919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366D59-3C6A-44AB-90AA-10775F3CEE1B}" type="slidenum">
              <a:rPr lang="fr-FR" smtClean="0"/>
              <a:t>1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1460980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8458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890043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718214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556796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54409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106127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704695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10153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40631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8018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dirty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045298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1077666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ZoneTexte 184">
            <a:extLst>
              <a:ext uri="{FF2B5EF4-FFF2-40B4-BE49-F238E27FC236}">
                <a16:creationId xmlns:a16="http://schemas.microsoft.com/office/drawing/2014/main" id="{51620FCE-0E03-4AF5-8199-FAEE4C9818F6}"/>
              </a:ext>
            </a:extLst>
          </p:cNvPr>
          <p:cNvSpPr txBox="1"/>
          <p:nvPr/>
        </p:nvSpPr>
        <p:spPr>
          <a:xfrm>
            <a:off x="551367" y="2244832"/>
            <a:ext cx="57541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 | Environmental conditions impact the number of gene isoforms per reaction within Atacama plant species. 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tmap of expanded reactions when comparing the average number of gene isoforms per reaction in all Atacama plants or specific vegetation belts (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.e. 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eppe, Puna, </a:t>
            </a:r>
            <a:r>
              <a:rPr lang="en-GB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puna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ith the average number of gene isoforms per reaction in related Sister species.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8A472D7B-D1C5-4727-8B5F-F2552A5C67D8}"/>
              </a:ext>
            </a:extLst>
          </p:cNvPr>
          <p:cNvSpPr/>
          <p:nvPr/>
        </p:nvSpPr>
        <p:spPr>
          <a:xfrm>
            <a:off x="545550" y="532866"/>
            <a:ext cx="5760000" cy="1644277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pic>
        <p:nvPicPr>
          <p:cNvPr id="9" name="Graphique 8">
            <a:extLst>
              <a:ext uri="{FF2B5EF4-FFF2-40B4-BE49-F238E27FC236}">
                <a16:creationId xmlns:a16="http://schemas.microsoft.com/office/drawing/2014/main" id="{ECF32734-BCA7-8FEC-1B59-67C99FE79DB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1805550" y="624863"/>
            <a:ext cx="3240000" cy="14602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6318867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350" row="1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9871AA9D-C2C8-41E6-9D93-8AF3495D5A01}">
  <we:reference id="wa200000113" version="1.0.0.0" store="fr-FR" storeType="OMEX"/>
  <we:alternateReferences>
    <we:reference id="wa200000113" version="1.0.0.0" store="WA200000113" storeType="OMEX"/>
  </we:alternateReferences>
  <we:properties/>
  <we:bindings/>
  <we:snapshot xmlns:r="http://schemas.openxmlformats.org/officeDocument/2006/relationships"/>
</we:webextension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728</TotalTime>
  <Words>67</Words>
  <Application>Microsoft Office PowerPoint</Application>
  <PresentationFormat>Format A4 (210 x 297 mm)</PresentationFormat>
  <Paragraphs>2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Calibri</vt:lpstr>
      <vt:lpstr>Arial</vt:lpstr>
      <vt:lpstr>Calibri Light</vt:lpstr>
      <vt:lpstr>Times New Roman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omas Dussarrat</dc:creator>
  <cp:lastModifiedBy>Thomas Dussarrat</cp:lastModifiedBy>
  <cp:revision>1369</cp:revision>
  <dcterms:created xsi:type="dcterms:W3CDTF">2020-07-29T08:33:47Z</dcterms:created>
  <dcterms:modified xsi:type="dcterms:W3CDTF">2023-08-23T12:40:58Z</dcterms:modified>
</cp:coreProperties>
</file>